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5C565-BFC2-47EA-9BCA-733BDEBB7FD4}" type="datetimeFigureOut">
              <a:rPr lang="it-IT" smtClean="0"/>
              <a:t>14/03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667DB-82AC-4043-B663-D14D73FCBB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10507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5C565-BFC2-47EA-9BCA-733BDEBB7FD4}" type="datetimeFigureOut">
              <a:rPr lang="it-IT" smtClean="0"/>
              <a:t>14/03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667DB-82AC-4043-B663-D14D73FCBB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41056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5C565-BFC2-47EA-9BCA-733BDEBB7FD4}" type="datetimeFigureOut">
              <a:rPr lang="it-IT" smtClean="0"/>
              <a:t>14/03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667DB-82AC-4043-B663-D14D73FCBB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89238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5C565-BFC2-47EA-9BCA-733BDEBB7FD4}" type="datetimeFigureOut">
              <a:rPr lang="it-IT" smtClean="0"/>
              <a:t>14/03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667DB-82AC-4043-B663-D14D73FCBB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4184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5C565-BFC2-47EA-9BCA-733BDEBB7FD4}" type="datetimeFigureOut">
              <a:rPr lang="it-IT" smtClean="0"/>
              <a:t>14/03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667DB-82AC-4043-B663-D14D73FCBB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3327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5C565-BFC2-47EA-9BCA-733BDEBB7FD4}" type="datetimeFigureOut">
              <a:rPr lang="it-IT" smtClean="0"/>
              <a:t>14/03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667DB-82AC-4043-B663-D14D73FCBB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91232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5C565-BFC2-47EA-9BCA-733BDEBB7FD4}" type="datetimeFigureOut">
              <a:rPr lang="it-IT" smtClean="0"/>
              <a:t>14/03/202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667DB-82AC-4043-B663-D14D73FCBB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84007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5C565-BFC2-47EA-9BCA-733BDEBB7FD4}" type="datetimeFigureOut">
              <a:rPr lang="it-IT" smtClean="0"/>
              <a:t>14/03/202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667DB-82AC-4043-B663-D14D73FCBB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93395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5C565-BFC2-47EA-9BCA-733BDEBB7FD4}" type="datetimeFigureOut">
              <a:rPr lang="it-IT" smtClean="0"/>
              <a:t>14/03/202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667DB-82AC-4043-B663-D14D73FCBB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814947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5C565-BFC2-47EA-9BCA-733BDEBB7FD4}" type="datetimeFigureOut">
              <a:rPr lang="it-IT" smtClean="0"/>
              <a:t>14/03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667DB-82AC-4043-B663-D14D73FCBB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566673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05C565-BFC2-47EA-9BCA-733BDEBB7FD4}" type="datetimeFigureOut">
              <a:rPr lang="it-IT" smtClean="0"/>
              <a:t>14/03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5667DB-82AC-4043-B663-D14D73FCBB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9154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5C565-BFC2-47EA-9BCA-733BDEBB7FD4}" type="datetimeFigureOut">
              <a:rPr lang="it-IT" smtClean="0"/>
              <a:t>14/03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5667DB-82AC-4043-B663-D14D73FCBBE7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747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7567" y="404665"/>
            <a:ext cx="7872886" cy="53285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ttangolo 2"/>
          <p:cNvSpPr/>
          <p:nvPr/>
        </p:nvSpPr>
        <p:spPr>
          <a:xfrm>
            <a:off x="7650000" y="1783482"/>
            <a:ext cx="432000" cy="30755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" name="Rettangolo 3"/>
          <p:cNvSpPr/>
          <p:nvPr/>
        </p:nvSpPr>
        <p:spPr>
          <a:xfrm>
            <a:off x="2313913" y="2096346"/>
            <a:ext cx="5768087" cy="369101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" name="Rettangolo 4"/>
          <p:cNvSpPr/>
          <p:nvPr/>
        </p:nvSpPr>
        <p:spPr>
          <a:xfrm>
            <a:off x="2313912" y="2470952"/>
            <a:ext cx="1674000" cy="33286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" name="CasellaDiTesto 5"/>
          <p:cNvSpPr txBox="1"/>
          <p:nvPr/>
        </p:nvSpPr>
        <p:spPr>
          <a:xfrm>
            <a:off x="517567" y="5877272"/>
            <a:ext cx="823089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600"/>
              <a:t>Figure </a:t>
            </a:r>
            <a:r>
              <a:rPr lang="it-IT" sz="1600" smtClean="0"/>
              <a:t>S4: </a:t>
            </a:r>
            <a:r>
              <a:rPr lang="en-US" sz="1600" dirty="0"/>
              <a:t>amino acid alignment between the M sequences obtained in this study and the reference strain BH80/11-4. The mutation hot spot of the </a:t>
            </a:r>
            <a:r>
              <a:rPr lang="en-US" sz="1600" dirty="0" err="1"/>
              <a:t>Gc</a:t>
            </a:r>
            <a:r>
              <a:rPr lang="en-US" sz="1600" dirty="0"/>
              <a:t> protein is highlighted in red (aa. 493-629, Fisher at al., 2013)</a:t>
            </a:r>
            <a:endParaRPr lang="it-IT" sz="1600" dirty="0"/>
          </a:p>
        </p:txBody>
      </p:sp>
    </p:spTree>
    <p:extLst>
      <p:ext uri="{BB962C8B-B14F-4D97-AF65-F5344CB8AC3E}">
        <p14:creationId xmlns:p14="http://schemas.microsoft.com/office/powerpoint/2010/main" val="152584864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2</TotalTime>
  <Words>43</Words>
  <Application>Microsoft Office PowerPoint</Application>
  <PresentationFormat>Presentazione su schermo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ei Giudici Silvia</dc:creator>
  <cp:lastModifiedBy>Dei Giudici Silvia</cp:lastModifiedBy>
  <cp:revision>13</cp:revision>
  <dcterms:created xsi:type="dcterms:W3CDTF">2024-07-16T15:30:20Z</dcterms:created>
  <dcterms:modified xsi:type="dcterms:W3CDTF">2025-03-14T17:24:03Z</dcterms:modified>
</cp:coreProperties>
</file>